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3" r:id="rId2"/>
    <p:sldId id="264" r:id="rId3"/>
    <p:sldId id="265" r:id="rId4"/>
    <p:sldId id="262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358B52D-F43D-1F46-830C-2CB8093D42F5}" v="1" dt="2021-10-22T06:09:56.15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8" autoAdjust="0"/>
    <p:restoredTop sz="94660"/>
  </p:normalViewPr>
  <p:slideViewPr>
    <p:cSldViewPr snapToGrid="0">
      <p:cViewPr>
        <p:scale>
          <a:sx n="110" d="100"/>
          <a:sy n="110" d="100"/>
        </p:scale>
        <p:origin x="664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lakolanu" userId="bc35d601-71c3-4aae-a2e8-f2f36b0abfb3" providerId="ADAL" clId="{CA3780F6-248A-4AFD-83C4-E2F17D6095C3}"/>
    <pc:docChg chg="modSld sldOrd">
      <pc:chgData name="Palakolanu" userId="bc35d601-71c3-4aae-a2e8-f2f36b0abfb3" providerId="ADAL" clId="{CA3780F6-248A-4AFD-83C4-E2F17D6095C3}" dt="2021-10-11T16:15:33.220" v="11" actId="20577"/>
      <pc:docMkLst>
        <pc:docMk/>
      </pc:docMkLst>
      <pc:sldChg chg="modSp mod ord">
        <pc:chgData name="Palakolanu" userId="bc35d601-71c3-4aae-a2e8-f2f36b0abfb3" providerId="ADAL" clId="{CA3780F6-248A-4AFD-83C4-E2F17D6095C3}" dt="2021-10-11T15:54:01.828" v="5" actId="20577"/>
        <pc:sldMkLst>
          <pc:docMk/>
          <pc:sldMk cId="2633393426" sldId="263"/>
        </pc:sldMkLst>
        <pc:spChg chg="mod">
          <ac:chgData name="Palakolanu" userId="bc35d601-71c3-4aae-a2e8-f2f36b0abfb3" providerId="ADAL" clId="{CA3780F6-248A-4AFD-83C4-E2F17D6095C3}" dt="2021-10-11T15:54:01.828" v="5" actId="20577"/>
          <ac:spMkLst>
            <pc:docMk/>
            <pc:sldMk cId="2633393426" sldId="263"/>
            <ac:spMk id="2" creationId="{EC430E82-CA7E-41B7-AFAC-81899FD98526}"/>
          </ac:spMkLst>
        </pc:spChg>
      </pc:sldChg>
      <pc:sldChg chg="modSp mod ord">
        <pc:chgData name="Palakolanu" userId="bc35d601-71c3-4aae-a2e8-f2f36b0abfb3" providerId="ADAL" clId="{CA3780F6-248A-4AFD-83C4-E2F17D6095C3}" dt="2021-10-11T16:15:25.856" v="6" actId="20577"/>
        <pc:sldMkLst>
          <pc:docMk/>
          <pc:sldMk cId="970869560" sldId="264"/>
        </pc:sldMkLst>
        <pc:spChg chg="mod">
          <ac:chgData name="Palakolanu" userId="bc35d601-71c3-4aae-a2e8-f2f36b0abfb3" providerId="ADAL" clId="{CA3780F6-248A-4AFD-83C4-E2F17D6095C3}" dt="2021-10-11T16:15:25.856" v="6" actId="20577"/>
          <ac:spMkLst>
            <pc:docMk/>
            <pc:sldMk cId="970869560" sldId="264"/>
            <ac:spMk id="5" creationId="{BC90BB52-67D5-475E-82B2-D1B4981A2087}"/>
          </ac:spMkLst>
        </pc:spChg>
      </pc:sldChg>
      <pc:sldChg chg="modSp mod">
        <pc:chgData name="Palakolanu" userId="bc35d601-71c3-4aae-a2e8-f2f36b0abfb3" providerId="ADAL" clId="{CA3780F6-248A-4AFD-83C4-E2F17D6095C3}" dt="2021-10-11T16:15:33.220" v="11" actId="20577"/>
        <pc:sldMkLst>
          <pc:docMk/>
          <pc:sldMk cId="0" sldId="265"/>
        </pc:sldMkLst>
        <pc:spChg chg="mod">
          <ac:chgData name="Palakolanu" userId="bc35d601-71c3-4aae-a2e8-f2f36b0abfb3" providerId="ADAL" clId="{CA3780F6-248A-4AFD-83C4-E2F17D6095C3}" dt="2021-10-11T16:15:33.220" v="11" actId="20577"/>
          <ac:spMkLst>
            <pc:docMk/>
            <pc:sldMk cId="0" sldId="265"/>
            <ac:spMk id="6" creationId="{00000000-0000-0000-0000-000000000000}"/>
          </ac:spMkLst>
        </pc:spChg>
      </pc:sldChg>
    </pc:docChg>
  </pc:docChgLst>
  <pc:docChgLst>
    <pc:chgData name="Sudhakarreddy, Palakolanu (ICRISAT-IN)" userId="bc35d601-71c3-4aae-a2e8-f2f36b0abfb3" providerId="ADAL" clId="{CA3780F6-248A-4AFD-83C4-E2F17D6095C3}"/>
    <pc:docChg chg="custSel delSld modSld">
      <pc:chgData name="Sudhakarreddy, Palakolanu (ICRISAT-IN)" userId="bc35d601-71c3-4aae-a2e8-f2f36b0abfb3" providerId="ADAL" clId="{CA3780F6-248A-4AFD-83C4-E2F17D6095C3}" dt="2021-10-11T18:14:35.238" v="1" actId="47"/>
      <pc:docMkLst>
        <pc:docMk/>
      </pc:docMkLst>
      <pc:sldChg chg="delSp del mod">
        <pc:chgData name="Sudhakarreddy, Palakolanu (ICRISAT-IN)" userId="bc35d601-71c3-4aae-a2e8-f2f36b0abfb3" providerId="ADAL" clId="{CA3780F6-248A-4AFD-83C4-E2F17D6095C3}" dt="2021-10-11T18:14:35.238" v="1" actId="47"/>
        <pc:sldMkLst>
          <pc:docMk/>
          <pc:sldMk cId="1879340736" sldId="261"/>
        </pc:sldMkLst>
        <pc:picChg chg="del">
          <ac:chgData name="Sudhakarreddy, Palakolanu (ICRISAT-IN)" userId="bc35d601-71c3-4aae-a2e8-f2f36b0abfb3" providerId="ADAL" clId="{CA3780F6-248A-4AFD-83C4-E2F17D6095C3}" dt="2021-10-11T18:14:32.469" v="0" actId="21"/>
          <ac:picMkLst>
            <pc:docMk/>
            <pc:sldMk cId="1879340736" sldId="261"/>
            <ac:picMk id="3" creationId="{00000000-0000-0000-0000-000000000000}"/>
          </ac:picMkLst>
        </pc:picChg>
      </pc:sldChg>
    </pc:docChg>
  </pc:docChgLst>
  <pc:docChgLst>
    <pc:chgData name="Sudhakarreddy, Palakolanu (ICRISAT-IN)" userId="bc35d601-71c3-4aae-a2e8-f2f36b0abfb3" providerId="ADAL" clId="{9358B52D-F43D-1F46-830C-2CB8093D42F5}"/>
    <pc:docChg chg="custSel modSld">
      <pc:chgData name="Sudhakarreddy, Palakolanu (ICRISAT-IN)" userId="bc35d601-71c3-4aae-a2e8-f2f36b0abfb3" providerId="ADAL" clId="{9358B52D-F43D-1F46-830C-2CB8093D42F5}" dt="2021-10-22T06:10:52.793" v="16" actId="1036"/>
      <pc:docMkLst>
        <pc:docMk/>
      </pc:docMkLst>
      <pc:sldChg chg="modSp mod">
        <pc:chgData name="Sudhakarreddy, Palakolanu (ICRISAT-IN)" userId="bc35d601-71c3-4aae-a2e8-f2f36b0abfb3" providerId="ADAL" clId="{9358B52D-F43D-1F46-830C-2CB8093D42F5}" dt="2021-10-22T06:10:52.793" v="16" actId="1036"/>
        <pc:sldMkLst>
          <pc:docMk/>
          <pc:sldMk cId="567693438" sldId="260"/>
        </pc:sldMkLst>
        <pc:spChg chg="mod">
          <ac:chgData name="Sudhakarreddy, Palakolanu (ICRISAT-IN)" userId="bc35d601-71c3-4aae-a2e8-f2f36b0abfb3" providerId="ADAL" clId="{9358B52D-F43D-1F46-830C-2CB8093D42F5}" dt="2021-10-22T06:10:47.187" v="6" actId="554"/>
          <ac:spMkLst>
            <pc:docMk/>
            <pc:sldMk cId="567693438" sldId="260"/>
            <ac:spMk id="7" creationId="{00000000-0000-0000-0000-000000000000}"/>
          </ac:spMkLst>
        </pc:spChg>
        <pc:spChg chg="mod">
          <ac:chgData name="Sudhakarreddy, Palakolanu (ICRISAT-IN)" userId="bc35d601-71c3-4aae-a2e8-f2f36b0abfb3" providerId="ADAL" clId="{9358B52D-F43D-1F46-830C-2CB8093D42F5}" dt="2021-10-22T06:10:47.187" v="6" actId="554"/>
          <ac:spMkLst>
            <pc:docMk/>
            <pc:sldMk cId="567693438" sldId="260"/>
            <ac:spMk id="8" creationId="{00000000-0000-0000-0000-000000000000}"/>
          </ac:spMkLst>
        </pc:spChg>
        <pc:picChg chg="mod">
          <ac:chgData name="Sudhakarreddy, Palakolanu (ICRISAT-IN)" userId="bc35d601-71c3-4aae-a2e8-f2f36b0abfb3" providerId="ADAL" clId="{9358B52D-F43D-1F46-830C-2CB8093D42F5}" dt="2021-10-22T06:10:52.793" v="16" actId="1036"/>
          <ac:picMkLst>
            <pc:docMk/>
            <pc:sldMk cId="567693438" sldId="260"/>
            <ac:picMk id="5" creationId="{00000000-0000-0000-0000-000000000000}"/>
          </ac:picMkLst>
        </pc:picChg>
        <pc:picChg chg="mod">
          <ac:chgData name="Sudhakarreddy, Palakolanu (ICRISAT-IN)" userId="bc35d601-71c3-4aae-a2e8-f2f36b0abfb3" providerId="ADAL" clId="{9358B52D-F43D-1F46-830C-2CB8093D42F5}" dt="2021-10-22T06:10:52.793" v="16" actId="1036"/>
          <ac:picMkLst>
            <pc:docMk/>
            <pc:sldMk cId="567693438" sldId="260"/>
            <ac:picMk id="6" creationId="{00000000-0000-0000-0000-000000000000}"/>
          </ac:picMkLst>
        </pc:picChg>
      </pc:sldChg>
      <pc:sldChg chg="addSp delSp modSp mod">
        <pc:chgData name="Sudhakarreddy, Palakolanu (ICRISAT-IN)" userId="bc35d601-71c3-4aae-a2e8-f2f36b0abfb3" providerId="ADAL" clId="{9358B52D-F43D-1F46-830C-2CB8093D42F5}" dt="2021-10-22T06:10:29.950" v="5" actId="732"/>
        <pc:sldMkLst>
          <pc:docMk/>
          <pc:sldMk cId="2570040877" sldId="262"/>
        </pc:sldMkLst>
        <pc:grpChg chg="del">
          <ac:chgData name="Sudhakarreddy, Palakolanu (ICRISAT-IN)" userId="bc35d601-71c3-4aae-a2e8-f2f36b0abfb3" providerId="ADAL" clId="{9358B52D-F43D-1F46-830C-2CB8093D42F5}" dt="2021-10-22T05:48:36.723" v="0" actId="478"/>
          <ac:grpSpMkLst>
            <pc:docMk/>
            <pc:sldMk cId="2570040877" sldId="262"/>
            <ac:grpSpMk id="3" creationId="{00000000-0000-0000-0000-000000000000}"/>
          </ac:grpSpMkLst>
        </pc:grpChg>
        <pc:picChg chg="add mod modCrop">
          <ac:chgData name="Sudhakarreddy, Palakolanu (ICRISAT-IN)" userId="bc35d601-71c3-4aae-a2e8-f2f36b0abfb3" providerId="ADAL" clId="{9358B52D-F43D-1F46-830C-2CB8093D42F5}" dt="2021-10-22T06:10:29.950" v="5" actId="732"/>
          <ac:picMkLst>
            <pc:docMk/>
            <pc:sldMk cId="2570040877" sldId="262"/>
            <ac:picMk id="2" creationId="{C4D3F16C-C54E-B04F-BCC0-0200DF11A3B3}"/>
          </ac:picMkLst>
        </pc:picChg>
        <pc:picChg chg="del topLvl">
          <ac:chgData name="Sudhakarreddy, Palakolanu (ICRISAT-IN)" userId="bc35d601-71c3-4aae-a2e8-f2f36b0abfb3" providerId="ADAL" clId="{9358B52D-F43D-1F46-830C-2CB8093D42F5}" dt="2021-10-22T05:48:36.723" v="0" actId="478"/>
          <ac:picMkLst>
            <pc:docMk/>
            <pc:sldMk cId="2570040877" sldId="262"/>
            <ac:picMk id="4" creationId="{00000000-0000-0000-0000-000000000000}"/>
          </ac:picMkLst>
        </pc:picChg>
        <pc:picChg chg="del topLvl">
          <ac:chgData name="Sudhakarreddy, Palakolanu (ICRISAT-IN)" userId="bc35d601-71c3-4aae-a2e8-f2f36b0abfb3" providerId="ADAL" clId="{9358B52D-F43D-1F46-830C-2CB8093D42F5}" dt="2021-10-22T05:48:38.721" v="1" actId="478"/>
          <ac:picMkLst>
            <pc:docMk/>
            <pc:sldMk cId="2570040877" sldId="262"/>
            <ac:picMk id="5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68D850-2C95-47F7-993F-08B0D64511E7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71B07F-2E04-4D08-9EAC-60F46589B5F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0516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628890-4F81-45B0-AB43-31980316EFD9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554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665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401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254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226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658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86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368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818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580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748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814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E00AE0-CD9E-43B7-97C9-3D8187758A61}" type="datetimeFigureOut">
              <a:rPr lang="en-US" smtClean="0"/>
              <a:pPr/>
              <a:t>10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B4BD5-443A-499E-BA2D-866B662B0B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75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C430E82-CA7E-41B7-AFAC-81899FD98526}"/>
              </a:ext>
            </a:extLst>
          </p:cNvPr>
          <p:cNvSpPr txBox="1"/>
          <p:nvPr/>
        </p:nvSpPr>
        <p:spPr>
          <a:xfrm>
            <a:off x="-712" y="7911"/>
            <a:ext cx="2173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EA2AABA-E600-4F6B-8A0C-ECA70D7B8E45}"/>
              </a:ext>
            </a:extLst>
          </p:cNvPr>
          <p:cNvGrpSpPr/>
          <p:nvPr/>
        </p:nvGrpSpPr>
        <p:grpSpPr>
          <a:xfrm>
            <a:off x="1386242" y="0"/>
            <a:ext cx="6592139" cy="6465332"/>
            <a:chOff x="685800" y="150834"/>
            <a:chExt cx="6592139" cy="6465332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C591530D-0413-4680-B81C-C3E3326EEFED}"/>
                </a:ext>
              </a:extLst>
            </p:cNvPr>
            <p:cNvSpPr/>
            <p:nvPr/>
          </p:nvSpPr>
          <p:spPr>
            <a:xfrm rot="1587732">
              <a:off x="6485994" y="3990797"/>
              <a:ext cx="1524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B78FB86D-B7B2-42DA-ABE7-B8162FC7A28E}"/>
                </a:ext>
              </a:extLst>
            </p:cNvPr>
            <p:cNvSpPr/>
            <p:nvPr/>
          </p:nvSpPr>
          <p:spPr>
            <a:xfrm>
              <a:off x="3429000" y="150834"/>
              <a:ext cx="762000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7A57EA0-FFD5-42AF-BE37-D16BDA5D03C5}"/>
                </a:ext>
              </a:extLst>
            </p:cNvPr>
            <p:cNvSpPr/>
            <p:nvPr/>
          </p:nvSpPr>
          <p:spPr>
            <a:xfrm rot="19037121">
              <a:off x="2228556" y="4338260"/>
              <a:ext cx="285275" cy="1512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272896AB-9E98-484A-A114-8A78BAFC5956}"/>
                </a:ext>
              </a:extLst>
            </p:cNvPr>
            <p:cNvSpPr/>
            <p:nvPr/>
          </p:nvSpPr>
          <p:spPr>
            <a:xfrm rot="13826790">
              <a:off x="2292507" y="831466"/>
              <a:ext cx="285275" cy="1512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772076FE-0DCD-456F-91E8-E62FE2A5EAEF}"/>
                </a:ext>
              </a:extLst>
            </p:cNvPr>
            <p:cNvGrpSpPr/>
            <p:nvPr/>
          </p:nvGrpSpPr>
          <p:grpSpPr>
            <a:xfrm>
              <a:off x="877139" y="227034"/>
              <a:ext cx="6400800" cy="6019800"/>
              <a:chOff x="1371600" y="304800"/>
              <a:chExt cx="6400800" cy="6019800"/>
            </a:xfrm>
          </p:grpSpPr>
          <p:sp>
            <p:nvSpPr>
              <p:cNvPr id="13" name="Oval 12">
                <a:extLst>
                  <a:ext uri="{FF2B5EF4-FFF2-40B4-BE49-F238E27FC236}">
                    <a16:creationId xmlns:a16="http://schemas.microsoft.com/office/drawing/2014/main" id="{29002BB9-2A40-4AB6-9719-6B2E7D4148FD}"/>
                  </a:ext>
                </a:extLst>
              </p:cNvPr>
              <p:cNvSpPr/>
              <p:nvPr/>
            </p:nvSpPr>
            <p:spPr>
              <a:xfrm>
                <a:off x="1371600" y="381000"/>
                <a:ext cx="6400800" cy="59436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pic>
            <p:nvPicPr>
              <p:cNvPr id="14" name="Picture 2">
                <a:extLst>
                  <a:ext uri="{FF2B5EF4-FFF2-40B4-BE49-F238E27FC236}">
                    <a16:creationId xmlns:a16="http://schemas.microsoft.com/office/drawing/2014/main" id="{6144A309-526C-4EE1-839A-FEA339D1090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371600" y="457201"/>
                <a:ext cx="6324600" cy="5714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3E3410DD-105D-4C75-B23A-C7B2347E0B41}"/>
                  </a:ext>
                </a:extLst>
              </p:cNvPr>
              <p:cNvSpPr/>
              <p:nvPr/>
            </p:nvSpPr>
            <p:spPr>
              <a:xfrm>
                <a:off x="2133600" y="5257800"/>
                <a:ext cx="152400" cy="152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D2BA5236-F5D1-47F8-9394-C3C688A568D6}"/>
                  </a:ext>
                </a:extLst>
              </p:cNvPr>
              <p:cNvSpPr/>
              <p:nvPr/>
            </p:nvSpPr>
            <p:spPr>
              <a:xfrm>
                <a:off x="7391400" y="4572000"/>
                <a:ext cx="76200" cy="152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1EEF7668-F100-49DC-A3A3-4FF3E1D0D3C9}"/>
                  </a:ext>
                </a:extLst>
              </p:cNvPr>
              <p:cNvSpPr/>
              <p:nvPr/>
            </p:nvSpPr>
            <p:spPr>
              <a:xfrm>
                <a:off x="2209800" y="1143000"/>
                <a:ext cx="76200" cy="152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D81A932A-8C73-4B94-BEBA-5E5464E04FBF}"/>
                  </a:ext>
                </a:extLst>
              </p:cNvPr>
              <p:cNvSpPr/>
              <p:nvPr/>
            </p:nvSpPr>
            <p:spPr>
              <a:xfrm>
                <a:off x="3581400" y="304800"/>
                <a:ext cx="762000" cy="304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94C1524-1065-4753-A9AA-C9B150C5F292}"/>
                </a:ext>
              </a:extLst>
            </p:cNvPr>
            <p:cNvSpPr txBox="1"/>
            <p:nvPr/>
          </p:nvSpPr>
          <p:spPr>
            <a:xfrm rot="17182383">
              <a:off x="565382" y="2208234"/>
              <a:ext cx="610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NIP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9E1ABEC-D68B-4F76-BCBC-46EA093E28A7}"/>
                </a:ext>
              </a:extLst>
            </p:cNvPr>
            <p:cNvSpPr txBox="1"/>
            <p:nvPr/>
          </p:nvSpPr>
          <p:spPr>
            <a:xfrm rot="19578243">
              <a:off x="1779423" y="569677"/>
              <a:ext cx="5668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SIP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77389A5-0E17-404B-B6B8-EC01FF8C4C22}"/>
                </a:ext>
              </a:extLst>
            </p:cNvPr>
            <p:cNvSpPr txBox="1"/>
            <p:nvPr/>
          </p:nvSpPr>
          <p:spPr>
            <a:xfrm rot="181650">
              <a:off x="3684257" y="6246834"/>
              <a:ext cx="5716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TIP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A9ACF89-3C27-49D6-81FA-3F5132E9CFBE}"/>
                </a:ext>
              </a:extLst>
            </p:cNvPr>
            <p:cNvSpPr txBox="1"/>
            <p:nvPr/>
          </p:nvSpPr>
          <p:spPr>
            <a:xfrm rot="2362016">
              <a:off x="6021149" y="688078"/>
              <a:ext cx="5813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PIPs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880F5257-AD8A-4E49-816C-054E8AAD4D60}"/>
              </a:ext>
            </a:extLst>
          </p:cNvPr>
          <p:cNvGrpSpPr/>
          <p:nvPr/>
        </p:nvGrpSpPr>
        <p:grpSpPr>
          <a:xfrm>
            <a:off x="8675243" y="361106"/>
            <a:ext cx="2232001" cy="1015663"/>
            <a:chOff x="6563501" y="316468"/>
            <a:chExt cx="2232001" cy="1015663"/>
          </a:xfrm>
        </p:grpSpPr>
        <p:sp>
          <p:nvSpPr>
            <p:cNvPr id="19" name="Isosceles Triangle 18">
              <a:extLst>
                <a:ext uri="{FF2B5EF4-FFF2-40B4-BE49-F238E27FC236}">
                  <a16:creationId xmlns:a16="http://schemas.microsoft.com/office/drawing/2014/main" id="{AB88D8E2-8662-4B79-B585-FC37CE483D3B}"/>
                </a:ext>
              </a:extLst>
            </p:cNvPr>
            <p:cNvSpPr>
              <a:spLocks/>
            </p:cNvSpPr>
            <p:nvPr/>
          </p:nvSpPr>
          <p:spPr>
            <a:xfrm>
              <a:off x="6563501" y="389068"/>
              <a:ext cx="180000" cy="180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Isosceles Triangle 19">
              <a:extLst>
                <a:ext uri="{FF2B5EF4-FFF2-40B4-BE49-F238E27FC236}">
                  <a16:creationId xmlns:a16="http://schemas.microsoft.com/office/drawing/2014/main" id="{04FD42B9-9653-4576-9CA3-D8491D69B5B5}"/>
                </a:ext>
              </a:extLst>
            </p:cNvPr>
            <p:cNvSpPr>
              <a:spLocks/>
            </p:cNvSpPr>
            <p:nvPr/>
          </p:nvSpPr>
          <p:spPr>
            <a:xfrm>
              <a:off x="6563501" y="617668"/>
              <a:ext cx="180000" cy="180000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Isosceles Triangle 20">
              <a:extLst>
                <a:ext uri="{FF2B5EF4-FFF2-40B4-BE49-F238E27FC236}">
                  <a16:creationId xmlns:a16="http://schemas.microsoft.com/office/drawing/2014/main" id="{9F85C545-498E-4D1F-9847-1123C57BC55F}"/>
                </a:ext>
              </a:extLst>
            </p:cNvPr>
            <p:cNvSpPr>
              <a:spLocks/>
            </p:cNvSpPr>
            <p:nvPr/>
          </p:nvSpPr>
          <p:spPr>
            <a:xfrm>
              <a:off x="6563501" y="846268"/>
              <a:ext cx="180000" cy="180000"/>
            </a:xfrm>
            <a:prstGeom prst="triangle">
              <a:avLst/>
            </a:prstGeom>
            <a:solidFill>
              <a:srgbClr val="808000"/>
            </a:solidFill>
            <a:ln>
              <a:solidFill>
                <a:srgbClr val="8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Isosceles Triangle 21">
              <a:extLst>
                <a:ext uri="{FF2B5EF4-FFF2-40B4-BE49-F238E27FC236}">
                  <a16:creationId xmlns:a16="http://schemas.microsoft.com/office/drawing/2014/main" id="{2FBA48CF-1E54-4364-AD72-06AD1E9D4D05}"/>
                </a:ext>
              </a:extLst>
            </p:cNvPr>
            <p:cNvSpPr>
              <a:spLocks/>
            </p:cNvSpPr>
            <p:nvPr/>
          </p:nvSpPr>
          <p:spPr>
            <a:xfrm>
              <a:off x="6563501" y="1074868"/>
              <a:ext cx="180000" cy="180000"/>
            </a:xfrm>
            <a:prstGeom prst="triangle">
              <a:avLst/>
            </a:prstGeom>
            <a:solidFill>
              <a:srgbClr val="00206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478ED5B-7DEC-4A1A-A744-6587BD7723E2}"/>
                </a:ext>
              </a:extLst>
            </p:cNvPr>
            <p:cNvSpPr txBox="1"/>
            <p:nvPr/>
          </p:nvSpPr>
          <p:spPr>
            <a:xfrm>
              <a:off x="6686526" y="316468"/>
              <a:ext cx="2108976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ennisetum glaucum </a:t>
              </a:r>
            </a:p>
            <a:p>
              <a:r>
                <a:rPr lang="en-IN" sz="1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orghum </a:t>
              </a:r>
              <a:r>
                <a:rPr lang="en-IN" sz="15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icolor</a:t>
              </a:r>
              <a:endParaRPr lang="en-IN" sz="15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IN" sz="15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Zea</a:t>
              </a:r>
              <a:r>
                <a:rPr lang="en-IN" sz="1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mays</a:t>
              </a:r>
            </a:p>
            <a:p>
              <a:r>
                <a:rPr lang="en-IN" sz="1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ryza sativ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333934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C90BB52-67D5-475E-82B2-D1B4981A2087}"/>
              </a:ext>
            </a:extLst>
          </p:cNvPr>
          <p:cNvSpPr txBox="1"/>
          <p:nvPr/>
        </p:nvSpPr>
        <p:spPr>
          <a:xfrm>
            <a:off x="0" y="0"/>
            <a:ext cx="20441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. 2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0" y="341200"/>
            <a:ext cx="12192000" cy="6516800"/>
            <a:chOff x="0" y="0"/>
            <a:chExt cx="9144000" cy="12649200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2"/>
            <a:srcRect l="4100" t="11458" r="2782" b="30208"/>
            <a:stretch>
              <a:fillRect/>
            </a:stretch>
          </p:blipFill>
          <p:spPr bwMode="auto">
            <a:xfrm>
              <a:off x="0" y="0"/>
              <a:ext cx="9144000" cy="426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7"/>
            <p:cNvPicPr>
              <a:picLocks noChangeAspect="1" noChangeArrowheads="1"/>
            </p:cNvPicPr>
            <p:nvPr/>
          </p:nvPicPr>
          <p:blipFill>
            <a:blip r:embed="rId3"/>
            <a:srcRect l="4100" t="17708" r="2782" b="26042"/>
            <a:stretch>
              <a:fillRect/>
            </a:stretch>
          </p:blipFill>
          <p:spPr bwMode="auto">
            <a:xfrm>
              <a:off x="0" y="4267200"/>
              <a:ext cx="9144000" cy="411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" name="Picture 2"/>
            <p:cNvPicPr>
              <a:picLocks noChangeAspect="1" noChangeArrowheads="1"/>
            </p:cNvPicPr>
            <p:nvPr/>
          </p:nvPicPr>
          <p:blipFill>
            <a:blip r:embed="rId4"/>
            <a:srcRect l="4100" t="27083" r="2782" b="9375"/>
            <a:stretch>
              <a:fillRect/>
            </a:stretch>
          </p:blipFill>
          <p:spPr bwMode="auto">
            <a:xfrm>
              <a:off x="0" y="8382000"/>
              <a:ext cx="9144000" cy="426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  <p:extLst>
      <p:ext uri="{BB962C8B-B14F-4D97-AF65-F5344CB8AC3E}">
        <p14:creationId xmlns:p14="http://schemas.microsoft.com/office/powerpoint/2010/main" val="9708695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562253" y="382137"/>
            <a:ext cx="9864637" cy="5527344"/>
            <a:chOff x="562253" y="382137"/>
            <a:chExt cx="9864637" cy="5527344"/>
          </a:xfrm>
        </p:grpSpPr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EBBE939C-AF2E-4658-A317-623F84DA5073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2"/>
            <a:srcRect l="1875" t="12500" r="5625" b="12500"/>
            <a:stretch>
              <a:fillRect/>
            </a:stretch>
          </p:blipFill>
          <p:spPr bwMode="auto">
            <a:xfrm>
              <a:off x="562253" y="382137"/>
              <a:ext cx="8759168" cy="55273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3"/>
            <a:srcRect l="48902" t="15625" r="38518" b="11458"/>
            <a:stretch>
              <a:fillRect/>
            </a:stretch>
          </p:blipFill>
          <p:spPr bwMode="auto">
            <a:xfrm>
              <a:off x="9441976" y="559558"/>
              <a:ext cx="984914" cy="52816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6" name="Rectangle 5"/>
          <p:cNvSpPr/>
          <p:nvPr/>
        </p:nvSpPr>
        <p:spPr>
          <a:xfrm>
            <a:off x="0" y="0"/>
            <a:ext cx="25186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. </a:t>
            </a:r>
            <a:r>
              <a:rPr lang="en-US" b="1">
                <a:latin typeface="Arial"/>
                <a:cs typeface="Arial"/>
              </a:rPr>
              <a:t>3</a:t>
            </a:r>
            <a:endParaRPr lang="en-US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17817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4D3F16C-C54E-B04F-BCC0-0200DF11A3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22" r="3087" b="4384"/>
          <a:stretch/>
        </p:blipFill>
        <p:spPr>
          <a:xfrm>
            <a:off x="1428750" y="393539"/>
            <a:ext cx="9046339" cy="5868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00408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0" y="61298"/>
            <a:ext cx="20441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. </a:t>
            </a:r>
            <a:r>
              <a:rPr lang="en-US" sz="1400" b="1">
                <a:latin typeface="Arial"/>
                <a:cs typeface="Arial"/>
              </a:rPr>
              <a:t>5 </a:t>
            </a:r>
            <a:endParaRPr lang="en-US" sz="1400" b="1" dirty="0">
              <a:latin typeface="Arial"/>
              <a:cs typeface="Arial"/>
            </a:endParaRPr>
          </a:p>
        </p:txBody>
      </p:sp>
      <p:pic>
        <p:nvPicPr>
          <p:cNvPr id="5" name="Picture 4" descr="Tissue specific normalized expression.tif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6987" y="1163283"/>
            <a:ext cx="4320000" cy="2878660"/>
          </a:xfrm>
          <a:prstGeom prst="rect">
            <a:avLst/>
          </a:prstGeom>
        </p:spPr>
      </p:pic>
      <p:pic>
        <p:nvPicPr>
          <p:cNvPr id="6" name="Picture 5" descr="Abiotic stress relative expression.ti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5308" y="1163283"/>
            <a:ext cx="3765703" cy="287866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542228" y="670813"/>
            <a:ext cx="3443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39629" y="670813"/>
            <a:ext cx="35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567693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1</TotalTime>
  <Words>35</Words>
  <Application>Microsoft Macintosh PowerPoint</Application>
  <PresentationFormat>Widescreen</PresentationFormat>
  <Paragraphs>1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SReddy</dc:creator>
  <cp:lastModifiedBy>Sudhakarreddy, Palakolanu (ICRISAT-IN)</cp:lastModifiedBy>
  <cp:revision>17</cp:revision>
  <dcterms:created xsi:type="dcterms:W3CDTF">2019-11-28T16:47:02Z</dcterms:created>
  <dcterms:modified xsi:type="dcterms:W3CDTF">2021-10-22T06:10:54Z</dcterms:modified>
</cp:coreProperties>
</file>